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73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2A0A05A-D40B-4317-8E7E-CC9975A3B9A3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5CDA54-4975-4D9B-A3F9-0CD1104814E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995046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Segnaposto immagine diapositiva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5363" name="Segnaposto note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it-IT" smtClean="0"/>
          </a:p>
        </p:txBody>
      </p:sp>
      <p:sp>
        <p:nvSpPr>
          <p:cNvPr id="15364" name="Segnaposto numero diapositiva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28005" indent="-37470849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155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31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465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62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fld id="{7B109FEB-5955-4A48-9361-A83CE66C3A22}" type="slidenum">
              <a:rPr lang="it-IT" sz="1200"/>
              <a:pPr eaLnBrk="1" hangingPunct="1"/>
              <a:t>1</a:t>
            </a:fld>
            <a:endParaRPr lang="it-IT" sz="120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5317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6217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85638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7092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622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9182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4669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6646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14659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8618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5600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F2C6BE-7351-456C-B9E2-AD8E3F28A589}" type="datetimeFigureOut">
              <a:rPr lang="it-IT" smtClean="0"/>
              <a:t>17/10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4FDCA-5D37-4BA3-8E4F-E7843DF048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0121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Immagine 4" descr="deltaK(1).eps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534"/>
          <a:stretch>
            <a:fillRect/>
          </a:stretch>
        </p:blipFill>
        <p:spPr bwMode="auto">
          <a:xfrm>
            <a:off x="4846638" y="369888"/>
            <a:ext cx="4187825" cy="3433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39" name="Immagine 6" descr="meanLnProb(2).eps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230"/>
          <a:stretch>
            <a:fillRect/>
          </a:stretch>
        </p:blipFill>
        <p:spPr bwMode="auto">
          <a:xfrm>
            <a:off x="293688" y="369888"/>
            <a:ext cx="4248150" cy="3433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40" name="CasellaDiTesto 8"/>
          <p:cNvSpPr txBox="1">
            <a:spLocks noChangeArrowheads="1"/>
          </p:cNvSpPr>
          <p:nvPr/>
        </p:nvSpPr>
        <p:spPr bwMode="auto">
          <a:xfrm>
            <a:off x="4203700" y="-38100"/>
            <a:ext cx="109061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it-IT" sz="1800">
                <a:latin typeface="Calibri" charset="0"/>
              </a:rPr>
              <a:t>SNPs</a:t>
            </a:r>
          </a:p>
        </p:txBody>
      </p:sp>
      <p:sp>
        <p:nvSpPr>
          <p:cNvPr id="14341" name="CasellaDiTesto 9"/>
          <p:cNvSpPr txBox="1">
            <a:spLocks noChangeArrowheads="1"/>
          </p:cNvSpPr>
          <p:nvPr/>
        </p:nvSpPr>
        <p:spPr bwMode="auto">
          <a:xfrm rot="-5400000">
            <a:off x="-970755" y="2129631"/>
            <a:ext cx="2468562" cy="2317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it-IT" sz="800" dirty="0" err="1">
                <a:latin typeface="Calibri" charset="0"/>
              </a:rPr>
              <a:t>Mean</a:t>
            </a:r>
            <a:r>
              <a:rPr lang="it-IT" sz="900" dirty="0">
                <a:latin typeface="Calibri" charset="0"/>
              </a:rPr>
              <a:t> </a:t>
            </a:r>
            <a:r>
              <a:rPr lang="it-IT" sz="900" dirty="0" smtClean="0">
                <a:latin typeface="Calibri" charset="0"/>
              </a:rPr>
              <a:t>L(K</a:t>
            </a:r>
            <a:r>
              <a:rPr lang="it-IT" sz="900" dirty="0">
                <a:latin typeface="Calibri" charset="0"/>
              </a:rPr>
              <a:t>)</a:t>
            </a:r>
          </a:p>
        </p:txBody>
      </p:sp>
      <p:sp>
        <p:nvSpPr>
          <p:cNvPr id="14342" name="CasellaDiTesto 10"/>
          <p:cNvSpPr txBox="1">
            <a:spLocks noChangeArrowheads="1"/>
          </p:cNvSpPr>
          <p:nvPr/>
        </p:nvSpPr>
        <p:spPr bwMode="auto">
          <a:xfrm>
            <a:off x="0" y="369888"/>
            <a:ext cx="5238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it-IT" sz="1800">
                <a:latin typeface="Calibri" charset="0"/>
              </a:rPr>
              <a:t>a)</a:t>
            </a:r>
          </a:p>
        </p:txBody>
      </p:sp>
      <p:sp>
        <p:nvSpPr>
          <p:cNvPr id="14343" name="CasellaDiTesto 11"/>
          <p:cNvSpPr txBox="1">
            <a:spLocks noChangeArrowheads="1"/>
          </p:cNvSpPr>
          <p:nvPr/>
        </p:nvSpPr>
        <p:spPr bwMode="auto">
          <a:xfrm>
            <a:off x="4670425" y="347663"/>
            <a:ext cx="5238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it-IT" sz="1800">
                <a:latin typeface="Calibri" charset="0"/>
              </a:rPr>
              <a:t>b)</a:t>
            </a:r>
          </a:p>
        </p:txBody>
      </p:sp>
      <p:sp>
        <p:nvSpPr>
          <p:cNvPr id="14344" name="CasellaDiTesto 12"/>
          <p:cNvSpPr txBox="1">
            <a:spLocks noChangeArrowheads="1"/>
          </p:cNvSpPr>
          <p:nvPr/>
        </p:nvSpPr>
        <p:spPr bwMode="auto">
          <a:xfrm>
            <a:off x="120650" y="3994150"/>
            <a:ext cx="5238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it-IT" sz="1800">
                <a:latin typeface="Calibri" charset="0"/>
              </a:rPr>
              <a:t>c)</a:t>
            </a:r>
          </a:p>
        </p:txBody>
      </p:sp>
      <p:graphicFrame>
        <p:nvGraphicFramePr>
          <p:cNvPr id="11" name="Tabella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37098633"/>
              </p:ext>
            </p:extLst>
          </p:nvPr>
        </p:nvGraphicFramePr>
        <p:xfrm>
          <a:off x="1009650" y="4062413"/>
          <a:ext cx="7202488" cy="2671763"/>
        </p:xfrm>
        <a:graphic>
          <a:graphicData uri="http://schemas.openxmlformats.org/drawingml/2006/table">
            <a:tbl>
              <a:tblPr/>
              <a:tblGrid>
                <a:gridCol w="663575"/>
                <a:gridCol w="574675"/>
                <a:gridCol w="714375"/>
                <a:gridCol w="836613"/>
                <a:gridCol w="749300"/>
                <a:gridCol w="836612"/>
                <a:gridCol w="836613"/>
                <a:gridCol w="663575"/>
                <a:gridCol w="663575"/>
                <a:gridCol w="663575"/>
              </a:tblGrid>
              <a:tr h="111125"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umber</a:t>
                      </a:r>
                      <a:r>
                        <a:rPr kumimoji="0" lang="it-IT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 of cluster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umber</a:t>
                      </a:r>
                      <a:r>
                        <a:rPr kumimoji="0" lang="it-IT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 of </a:t>
                      </a:r>
                      <a:r>
                        <a:rPr kumimoji="0" lang="it-IT" sz="7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runs</a:t>
                      </a:r>
                      <a:endParaRPr kumimoji="0" lang="it-IT" sz="7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L(K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ΔK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Wilcoxon significance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Similarity coefficient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Clusterednes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</a:tr>
              <a:tr h="334963"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mean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standard dev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mean</a:t>
                      </a: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 </a:t>
                      </a:r>
                      <a:r>
                        <a:rPr kumimoji="0" lang="it-IT" sz="7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similarity</a:t>
                      </a: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 </a:t>
                      </a:r>
                      <a:r>
                        <a:rPr kumimoji="0" lang="it-IT" sz="7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coeff</a:t>
                      </a: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standard dev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mean clusteredness coeff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standard dev.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85679.2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1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*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8567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8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4920.0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8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5505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6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638.35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9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3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4130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.78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94.83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7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5</a:t>
                      </a:r>
                      <a:r>
                        <a:rPr kumimoji="0" lang="it-IT" sz="7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#</a:t>
                      </a:r>
                      <a:endParaRPr kumimoji="0" lang="it-IT" sz="7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-128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3649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.51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.83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9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4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3316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9.41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5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9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2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3242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903.5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6.86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7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38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2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2962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23.17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3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2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2866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615.10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77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4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2752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157.39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98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9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0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2631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96.47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.03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81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3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0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2487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54.45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9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2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7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0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240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68.33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.06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8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9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0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2304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201.2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31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6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0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9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2198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647.4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7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5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4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2048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65.00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.10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5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5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9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1980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39.47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3.13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8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2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9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1956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120.41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4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ns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5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4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0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1125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1882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39.67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25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62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4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8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14300"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2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1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31834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994.78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-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p &lt; 0.0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51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14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48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it-IT" sz="7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-128"/>
                        </a:rPr>
                        <a:t>0.00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918491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295</Words>
  <Application>Microsoft Office PowerPoint</Application>
  <PresentationFormat>Presentazione su schermo (4:3)</PresentationFormat>
  <Paragraphs>219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FE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emanuelli</dc:creator>
  <cp:lastModifiedBy>francesco emanuelli</cp:lastModifiedBy>
  <cp:revision>3</cp:revision>
  <dcterms:created xsi:type="dcterms:W3CDTF">2012-10-17T13:24:20Z</dcterms:created>
  <dcterms:modified xsi:type="dcterms:W3CDTF">2012-10-17T15:22:53Z</dcterms:modified>
</cp:coreProperties>
</file>